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063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1470" y="10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7000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7165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9486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5938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6172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2669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426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1947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5780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8196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4079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4592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EFA29D04-308F-A54B-E6E0-895CE1A98F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418816"/>
              </p:ext>
            </p:extLst>
          </p:nvPr>
        </p:nvGraphicFramePr>
        <p:xfrm>
          <a:off x="295275" y="607170"/>
          <a:ext cx="6267450" cy="11320560"/>
        </p:xfrm>
        <a:graphic>
          <a:graphicData uri="http://schemas.openxmlformats.org/drawingml/2006/table">
            <a:tbl>
              <a:tblPr/>
              <a:tblGrid>
                <a:gridCol w="387621">
                  <a:extLst>
                    <a:ext uri="{9D8B030D-6E8A-4147-A177-3AD203B41FA5}">
                      <a16:colId xmlns:a16="http://schemas.microsoft.com/office/drawing/2014/main" val="1818155139"/>
                    </a:ext>
                  </a:extLst>
                </a:gridCol>
                <a:gridCol w="2287511">
                  <a:extLst>
                    <a:ext uri="{9D8B030D-6E8A-4147-A177-3AD203B41FA5}">
                      <a16:colId xmlns:a16="http://schemas.microsoft.com/office/drawing/2014/main" val="3438896615"/>
                    </a:ext>
                  </a:extLst>
                </a:gridCol>
                <a:gridCol w="291171">
                  <a:extLst>
                    <a:ext uri="{9D8B030D-6E8A-4147-A177-3AD203B41FA5}">
                      <a16:colId xmlns:a16="http://schemas.microsoft.com/office/drawing/2014/main" val="1414065413"/>
                    </a:ext>
                  </a:extLst>
                </a:gridCol>
                <a:gridCol w="378521">
                  <a:extLst>
                    <a:ext uri="{9D8B030D-6E8A-4147-A177-3AD203B41FA5}">
                      <a16:colId xmlns:a16="http://schemas.microsoft.com/office/drawing/2014/main" val="1687444335"/>
                    </a:ext>
                  </a:extLst>
                </a:gridCol>
                <a:gridCol w="387621">
                  <a:extLst>
                    <a:ext uri="{9D8B030D-6E8A-4147-A177-3AD203B41FA5}">
                      <a16:colId xmlns:a16="http://schemas.microsoft.com/office/drawing/2014/main" val="870031592"/>
                    </a:ext>
                  </a:extLst>
                </a:gridCol>
                <a:gridCol w="2147384">
                  <a:extLst>
                    <a:ext uri="{9D8B030D-6E8A-4147-A177-3AD203B41FA5}">
                      <a16:colId xmlns:a16="http://schemas.microsoft.com/office/drawing/2014/main" val="2503728287"/>
                    </a:ext>
                  </a:extLst>
                </a:gridCol>
                <a:gridCol w="387621">
                  <a:extLst>
                    <a:ext uri="{9D8B030D-6E8A-4147-A177-3AD203B41FA5}">
                      <a16:colId xmlns:a16="http://schemas.microsoft.com/office/drawing/2014/main" val="1218563271"/>
                    </a:ext>
                  </a:extLst>
                </a:gridCol>
              </a:tblGrid>
              <a:tr h="100118">
                <a:tc gridSpan="2"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22477"/>
                  </a:ext>
                </a:extLst>
              </a:tr>
              <a:tr h="10011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Up-regulated</a:t>
                      </a:r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B.</a:t>
                      </a:r>
                      <a:r>
                        <a:rPr lang="ko-KR" alt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bassiana</a:t>
                      </a:r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JEF-410</a:t>
                      </a:r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athway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ko-K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Down-regulated</a:t>
                      </a:r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B.</a:t>
                      </a:r>
                      <a:r>
                        <a:rPr lang="ko-KR" alt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bassiana</a:t>
                      </a:r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JEF-410</a:t>
                      </a:r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</a:t>
                      </a:r>
                      <a:r>
                        <a:rPr lang="en-US" altLang="ko-K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athway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0539292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1977942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KO ID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KEGG pathway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eq#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KO ID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KEGG pathway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eq#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0664519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6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cine, serine and threonin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5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5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ructose and mannos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243767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7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ysteine and methionin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1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itrogen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5649058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5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yrosin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2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rginine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068284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8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ryptophan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3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entose phosphate pathway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0624186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6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henylalanin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0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tarch and sucros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5737414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46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yanoamino acid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71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arbon fixation in photosynthetic organism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3176855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13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Ubiquinone and other terpenoid-quinone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8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ethan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1333642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43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tyrene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6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atty acid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8994488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42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ysosome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7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atty acid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7368222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1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colysis / Gluconeogen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6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cerolipid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162421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0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tarch and sucros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0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phingolipid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5560455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2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mino sugar and nucleotide sugar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3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urin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9005071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2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yruvat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4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yrimidin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6980332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3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oxylate and dicarboxylat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5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lanine, aspartate and glutamat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2765625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62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Inositol phosphat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6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cine, serine and threonin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322789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8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ethan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8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Valine, leucine and isoleucine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956634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1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itrogen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9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Valine, leucine and isoleucine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6260793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64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cerophospholipid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8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ryptophan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262399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0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phingolipid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46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yanoamino acid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807670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0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ysine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77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antothenate and CoA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2719209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48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utathion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99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Biosynthesis of various plant secondary metabolite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1039313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4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henylpropanoid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27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minobenzoate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7435542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27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minobenzoate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43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tyrene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921948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201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BC transporter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79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trazine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2669643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7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phingolipid signaling pathway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7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phingolipid signaling pathway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9356585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46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eroxisome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22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RIG-I-like receptor signaling pathway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3261577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3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entose phosphate pathway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3942547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4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entose and glucuronate interconversion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2987685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5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ructose and mannos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4410698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52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alactos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0251437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53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scorbate and aldarat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1710265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4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ropanoat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0430923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2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ulfur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6251369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73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utin, suberine and wax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3534553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6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cerolipid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0330843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65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Ether lipid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5277895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3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urin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063139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1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ysine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55071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2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rginine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5469929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40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henylalanine, tyrosine and tryptophan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408814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43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aurine and hypotaurine metabolis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6347112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1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-Glycan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1382953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13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Various types of N-glycan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4528141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1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Other glycan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688245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0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erpenoid backbone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1285573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5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Isoquinoline alkaloid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7523124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6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ropane, piperidine and pyridine alkaloid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4810192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6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onobactam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1820412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40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ovobiocin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4954325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404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taurosporine biosynthe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9227831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62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Benzoate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2358749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64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luorobenzoate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883977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6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hlorocyclohexane and chlorobenzene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7427754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23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oluene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1964984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79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trazine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3094779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2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Dioxin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797438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26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aphthalene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6020231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24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olycyclic aromatic hydrocarbon degrada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8963602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82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Drug metabolism - cytochrome P450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7148401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4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rotein processing in endoplasmic reticulu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4171703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16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APK signaling pathway - plant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9744179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1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APK signaling pathway - yeast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3046305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66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IF-1 signaling pathway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4068537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68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oxO signaling pathway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9403599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8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euroactive ligand-receptor interac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7989315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38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utophagy - yeast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276471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217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ecropto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0147134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2024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Quorum sensing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573766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22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ucagon signaling pathway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5266276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32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PAR signaling pathway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5403911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19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hyroid hormone signaling pathway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280596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14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Renin-angiotensin syste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4694231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72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ancreatic secre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4945257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74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rotein digestion and absorp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082355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77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Vitamin digestion and absorption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5158347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725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holinergic synapse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5504164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211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ongevity regulating pathway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065877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212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ongevity regulating pathway - worm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2551561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213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ongevity regulating pathway - multiple specie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5334047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06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icroRNAs in cancer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6219620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08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hemical carcinogenesis - reactive oxygen specie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7146872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30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entral carbon metabolism in cancer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0407426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64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Influenza A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250515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014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myotrophic lateral sclerosi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3351933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022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athways of neurodegeneration - multiple diseases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3487763"/>
                  </a:ext>
                </a:extLst>
              </a:tr>
              <a:tr h="100118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1523 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ntifolate resistance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864" marR="3864" marT="386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6631813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3BA6720D-B232-B1B6-4A0B-23BEB08D8ED1}"/>
              </a:ext>
            </a:extLst>
          </p:cNvPr>
          <p:cNvSpPr txBox="1"/>
          <p:nvPr/>
        </p:nvSpPr>
        <p:spPr>
          <a:xfrm>
            <a:off x="198248" y="230090"/>
            <a:ext cx="6094602" cy="455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S4 Table. KEGG pathway of infecting </a:t>
            </a:r>
            <a:r>
              <a:rPr lang="en-US" altLang="ko-KR" sz="14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B. bassiana</a:t>
            </a:r>
            <a:r>
              <a:rPr lang="en-US" altLang="ko-KR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 JEF-410 DEGs.</a:t>
            </a:r>
            <a:endParaRPr lang="ko-KR" altLang="ko-KR" sz="1400" dirty="0">
              <a:effectLst/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268901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</TotalTime>
  <Words>617</Words>
  <Application>Microsoft Office PowerPoint</Application>
  <PresentationFormat>와이드스크린</PresentationFormat>
  <Paragraphs>34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굴림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소은</dc:creator>
  <cp:lastModifiedBy>김재수</cp:lastModifiedBy>
  <cp:revision>6</cp:revision>
  <dcterms:created xsi:type="dcterms:W3CDTF">2022-09-14T06:04:29Z</dcterms:created>
  <dcterms:modified xsi:type="dcterms:W3CDTF">2023-01-06T05:24:49Z</dcterms:modified>
</cp:coreProperties>
</file>